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CC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5306" autoAdjust="0"/>
  </p:normalViewPr>
  <p:slideViewPr>
    <p:cSldViewPr>
      <p:cViewPr varScale="1">
        <p:scale>
          <a:sx n="40" d="100"/>
          <a:sy n="40" d="100"/>
        </p:scale>
        <p:origin x="-1675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EC8D4F-1E3A-48BC-88A3-8883E96412C8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55B436-7390-458B-9B11-99A4579C807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32500" lnSpcReduction="20000"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55B436-7390-458B-9B11-99A4579C807F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C07918-5C06-4E2D-958F-0D3301EAEDD4}" type="datetimeFigureOut">
              <a:rPr lang="en-US" smtClean="0"/>
              <a:pPr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880A95-DE65-4EDA-A414-A94518D643A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3400" y="1295400"/>
            <a:ext cx="3926606" cy="3962400"/>
          </a:xfrm>
          <a:prstGeom prst="rect">
            <a:avLst/>
          </a:prstGeom>
          <a:solidFill>
            <a:srgbClr val="99FFCC"/>
          </a:solidFill>
          <a:ln w="9525">
            <a:solidFill>
              <a:srgbClr val="00B050"/>
            </a:solidFill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876801" y="1295400"/>
            <a:ext cx="3899101" cy="3931920"/>
          </a:xfrm>
          <a:prstGeom prst="rect">
            <a:avLst/>
          </a:prstGeom>
          <a:noFill/>
          <a:ln w="9525">
            <a:solidFill>
              <a:srgbClr val="00B050"/>
            </a:solidFill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1754507" y="457200"/>
            <a:ext cx="5497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dirty="0" smtClean="0"/>
              <a:t>Ingenuity pathway analysis revealing  the pathways</a:t>
            </a:r>
          </a:p>
          <a:p>
            <a:pPr algn="ctr"/>
            <a:r>
              <a:rPr lang="it-IT" dirty="0" smtClean="0"/>
              <a:t>significantly changed after the DFO/Dp44mT treatments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7325759" y="6260068"/>
            <a:ext cx="17043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 smtClean="0"/>
              <a:t>Additional </a:t>
            </a:r>
            <a:r>
              <a:rPr lang="it-IT" b="1" smtClean="0"/>
              <a:t>file </a:t>
            </a:r>
            <a:r>
              <a:rPr lang="it-IT" b="1" smtClean="0"/>
              <a:t>7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133600" y="5410200"/>
            <a:ext cx="5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DFO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6411645" y="542186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Dp44mT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ngarzoneitalia</dc:creator>
  <cp:lastModifiedBy>bongarzoneitalia</cp:lastModifiedBy>
  <cp:revision>4</cp:revision>
  <dcterms:created xsi:type="dcterms:W3CDTF">2017-10-02T07:26:57Z</dcterms:created>
  <dcterms:modified xsi:type="dcterms:W3CDTF">2018-03-02T10:10:35Z</dcterms:modified>
</cp:coreProperties>
</file>